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44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6874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1166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7283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4341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997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673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9685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000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884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4185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585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096FEE-B0B0-4FF0-A745-51C27B051C64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1BED9-6DE8-4E69-B7A5-AA7497FD22E8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284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>
            <a:extLst>
              <a:ext uri="{FF2B5EF4-FFF2-40B4-BE49-F238E27FC236}">
                <a16:creationId xmlns:a16="http://schemas.microsoft.com/office/drawing/2014/main" id="{136A38CD-FA58-2C32-8FD8-8B9CB678E3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000" y="4056500"/>
            <a:ext cx="4680000" cy="2801500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59E69515-34BC-C28A-9BF1-7455B0A8A687}"/>
              </a:ext>
            </a:extLst>
          </p:cNvPr>
          <p:cNvSpPr txBox="1"/>
          <p:nvPr/>
        </p:nvSpPr>
        <p:spPr>
          <a:xfrm>
            <a:off x="389965" y="715991"/>
            <a:ext cx="2798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etween follow-ups 1 and 2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FC494322-D533-9BD3-626C-5F74329BA335}"/>
              </a:ext>
            </a:extLst>
          </p:cNvPr>
          <p:cNvSpPr txBox="1"/>
          <p:nvPr/>
        </p:nvSpPr>
        <p:spPr>
          <a:xfrm>
            <a:off x="5121998" y="715991"/>
            <a:ext cx="2798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etween follow-ups 1 and 3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6DD888BF-75E6-A22F-F846-363B2C7E0919}"/>
              </a:ext>
            </a:extLst>
          </p:cNvPr>
          <p:cNvSpPr txBox="1"/>
          <p:nvPr/>
        </p:nvSpPr>
        <p:spPr>
          <a:xfrm>
            <a:off x="389965" y="3792897"/>
            <a:ext cx="2798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etween follow-ups 2 and 3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985C1393-DBBC-B3FB-9767-AF801E770074}"/>
              </a:ext>
            </a:extLst>
          </p:cNvPr>
          <p:cNvSpPr txBox="1"/>
          <p:nvPr/>
        </p:nvSpPr>
        <p:spPr>
          <a:xfrm>
            <a:off x="6120000" y="4680000"/>
            <a:ext cx="284334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>
                <a:solidFill>
                  <a:srgbClr val="FF0000"/>
                </a:solidFill>
              </a:rPr>
              <a:t>Weight gain &gt;5 kg</a:t>
            </a:r>
          </a:p>
          <a:p>
            <a:r>
              <a:rPr lang="en-GB" sz="2400" dirty="0"/>
              <a:t>Weight change &lt;5 kg </a:t>
            </a:r>
          </a:p>
          <a:p>
            <a:r>
              <a:rPr lang="en-GB" sz="2400" dirty="0">
                <a:solidFill>
                  <a:srgbClr val="0070C0"/>
                </a:solidFill>
              </a:rPr>
              <a:t>Weight loss &gt;5 kg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BF433D30-E65C-5D9B-634A-8059673CA39B}"/>
              </a:ext>
            </a:extLst>
          </p:cNvPr>
          <p:cNvSpPr txBox="1"/>
          <p:nvPr/>
        </p:nvSpPr>
        <p:spPr>
          <a:xfrm>
            <a:off x="483637" y="0"/>
            <a:ext cx="893872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Bef>
                <a:spcPts val="600"/>
              </a:spcBef>
            </a:pPr>
            <a:r>
              <a:rPr lang="en-GB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.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individual 5- and 10-year weight changes among participants with weight dissatisfaction.</a:t>
            </a:r>
            <a:endParaRPr lang="fr-CH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2B176C3F-6D93-2475-D58A-378D879BE4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0" y="998581"/>
            <a:ext cx="4680000" cy="2801500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9A5F073D-FA1A-CE4A-3A96-C74B059358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2000" y="991397"/>
            <a:ext cx="4680000" cy="280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69960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47</Words>
  <Application>Microsoft Office PowerPoint</Application>
  <PresentationFormat>Format A4 (210 x 297 mm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dro Marques-Vidal</dc:creator>
  <cp:lastModifiedBy>Pedro Marques-Vidal</cp:lastModifiedBy>
  <cp:revision>7</cp:revision>
  <dcterms:created xsi:type="dcterms:W3CDTF">2024-10-02T09:01:56Z</dcterms:created>
  <dcterms:modified xsi:type="dcterms:W3CDTF">2025-07-16T06:03:56Z</dcterms:modified>
</cp:coreProperties>
</file>